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494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761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7998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207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505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564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117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006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877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490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834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718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D4FE17-6EF3-474C-B763-C9C6AF888134}" type="datetimeFigureOut">
              <a:rPr lang="en-US" smtClean="0"/>
              <a:t>11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86F48-4EFD-4E32-B69D-84CD4A7B90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005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9" name="Table 48"/>
          <p:cNvGraphicFramePr>
            <a:graphicFrameLocks noGrp="1"/>
          </p:cNvGraphicFramePr>
          <p:nvPr/>
        </p:nvGraphicFramePr>
        <p:xfrm>
          <a:off x="1227138" y="1056150"/>
          <a:ext cx="6956383" cy="4604024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1076818"/>
                <a:gridCol w="910720"/>
                <a:gridCol w="993769"/>
                <a:gridCol w="993769"/>
                <a:gridCol w="993769"/>
                <a:gridCol w="993769"/>
                <a:gridCol w="993769"/>
              </a:tblGrid>
              <a:tr h="428264"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600" dirty="0" smtClean="0"/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600" dirty="0" smtClean="0"/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 smtClean="0"/>
                        <a:t>Patient ID</a:t>
                      </a:r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600" b="1" dirty="0" smtClean="0"/>
                        <a:t> Pre-Vaccination</a:t>
                      </a:r>
                      <a:endParaRPr lang="en-US" sz="1600" b="1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dirty="0" smtClean="0"/>
                        <a:t>Post-Vaccination</a:t>
                      </a:r>
                      <a:endParaRPr lang="en-US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8828">
                <a:tc vMerge="1">
                  <a:txBody>
                    <a:bodyPr/>
                    <a:lstStyle/>
                    <a:p>
                      <a:endParaRPr lang="en-US" dirty="0" smtClean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 smtClean="0"/>
                        <a:t>HER2 ECD</a:t>
                      </a:r>
                      <a:endParaRPr lang="en-US" sz="1400" b="1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 smtClean="0"/>
                        <a:t>HER2 ICD</a:t>
                      </a:r>
                      <a:endParaRPr lang="en-US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 smtClean="0"/>
                        <a:t>CMV pep</a:t>
                      </a:r>
                      <a:r>
                        <a:rPr lang="en-US" sz="1400" b="1" baseline="0" dirty="0" smtClean="0"/>
                        <a:t> mix</a:t>
                      </a:r>
                      <a:endParaRPr lang="en-US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 smtClean="0"/>
                        <a:t>HER2 ECD</a:t>
                      </a:r>
                      <a:endParaRPr lang="en-US" sz="1400" b="1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 smtClean="0"/>
                        <a:t>HER2 ICD</a:t>
                      </a:r>
                      <a:endParaRPr lang="en-US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 smtClean="0"/>
                        <a:t>CMV pep</a:t>
                      </a:r>
                      <a:r>
                        <a:rPr lang="en-US" sz="1400" b="1" baseline="0" dirty="0" smtClean="0"/>
                        <a:t> mix</a:t>
                      </a:r>
                      <a:endParaRPr lang="en-US" sz="1400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r>
                        <a:rPr lang="en-US" dirty="0" smtClean="0"/>
                        <a:t>-001</a:t>
                      </a:r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9.32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1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2.6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r>
                        <a:rPr lang="en-US" dirty="0" smtClean="0"/>
                        <a:t>-002</a:t>
                      </a:r>
                      <a:endParaRPr lang="en-US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.32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30.7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9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04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r>
                        <a:rPr lang="en-US" dirty="0" smtClean="0"/>
                        <a:t>-003</a:t>
                      </a:r>
                      <a:endParaRPr lang="en-US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2.68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.6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481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.68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910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r>
                        <a:rPr lang="en-US" dirty="0" smtClean="0"/>
                        <a:t>-004</a:t>
                      </a:r>
                      <a:endParaRPr lang="en-US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90.68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8.6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9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47.3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1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7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r>
                        <a:rPr lang="en-US" dirty="0" smtClean="0"/>
                        <a:t>-006</a:t>
                      </a:r>
                      <a:endParaRPr lang="en-US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07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.68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36.7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r>
                        <a:rPr lang="en-US" dirty="0" smtClean="0"/>
                        <a:t>-008</a:t>
                      </a:r>
                      <a:endParaRPr lang="en-US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826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.68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096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-012</a:t>
                      </a:r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.32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.32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-013</a:t>
                      </a:r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5.32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.6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410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6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3637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-014</a:t>
                      </a:r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0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2.6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91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7.32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5.32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210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5055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-015</a:t>
                      </a:r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1.32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028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11.32</a:t>
                      </a:r>
                      <a:endParaRPr lang="en-US" sz="1400" dirty="0"/>
                    </a:p>
                  </a:txBody>
                  <a:tcPr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smtClean="0"/>
                        <a:t>43.3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smtClean="0"/>
                        <a:t>1559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0" name="TextBox 3"/>
          <p:cNvSpPr txBox="1">
            <a:spLocks noChangeArrowheads="1"/>
          </p:cNvSpPr>
          <p:nvPr/>
        </p:nvSpPr>
        <p:spPr bwMode="auto">
          <a:xfrm>
            <a:off x="1057855" y="386725"/>
            <a:ext cx="7511736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 smtClean="0"/>
              <a:t>Supplemental Table </a:t>
            </a:r>
            <a:r>
              <a:rPr lang="en-US" dirty="0" smtClean="0"/>
              <a:t>1.  dHER2ASCI </a:t>
            </a:r>
            <a:r>
              <a:rPr lang="en-US" dirty="0" err="1"/>
              <a:t>ELISpot</a:t>
            </a:r>
            <a:r>
              <a:rPr lang="en-US" dirty="0"/>
              <a:t> Results:  Number of </a:t>
            </a:r>
            <a:r>
              <a:rPr lang="en-US" dirty="0" err="1"/>
              <a:t>IFN</a:t>
            </a:r>
            <a:r>
              <a:rPr lang="en-US" dirty="0" err="1">
                <a:latin typeface="Symbol MT" pitchFamily="18" charset="2"/>
              </a:rPr>
              <a:t>g</a:t>
            </a:r>
            <a:r>
              <a:rPr lang="en-US" dirty="0"/>
              <a:t> Producing</a:t>
            </a:r>
          </a:p>
          <a:p>
            <a:pPr algn="ctr"/>
            <a:r>
              <a:rPr lang="en-US" dirty="0"/>
              <a:t>Cells per 10</a:t>
            </a:r>
            <a:r>
              <a:rPr lang="en-US" baseline="30000" dirty="0"/>
              <a:t>6</a:t>
            </a:r>
            <a:r>
              <a:rPr lang="en-US" dirty="0"/>
              <a:t> PBMC</a:t>
            </a:r>
          </a:p>
        </p:txBody>
      </p:sp>
      <p:sp>
        <p:nvSpPr>
          <p:cNvPr id="51" name="Text Box 6"/>
          <p:cNvSpPr txBox="1">
            <a:spLocks noChangeArrowheads="1"/>
          </p:cNvSpPr>
          <p:nvPr/>
        </p:nvSpPr>
        <p:spPr bwMode="auto">
          <a:xfrm>
            <a:off x="1215043" y="5697246"/>
            <a:ext cx="7091563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dirty="0"/>
              <a:t>PBMC isolated from dHER2-ASCI patient blood samples were analyzed for HER2-ECD </a:t>
            </a:r>
            <a:r>
              <a:rPr lang="en-US" sz="1200" dirty="0" smtClean="0"/>
              <a:t>and </a:t>
            </a:r>
            <a:r>
              <a:rPr lang="en-US" sz="1200" dirty="0"/>
              <a:t>HER2-ICD specific </a:t>
            </a:r>
            <a:r>
              <a:rPr lang="en-US" sz="1200" dirty="0" smtClean="0"/>
              <a:t>T cell responses </a:t>
            </a:r>
            <a:r>
              <a:rPr lang="en-US" sz="1200" dirty="0"/>
              <a:t>by </a:t>
            </a:r>
            <a:r>
              <a:rPr lang="en-US" sz="1200" dirty="0" err="1"/>
              <a:t>ELISpot</a:t>
            </a:r>
            <a:r>
              <a:rPr lang="en-US" sz="1200" dirty="0"/>
              <a:t> assay.  The number of </a:t>
            </a:r>
            <a:r>
              <a:rPr lang="en-US" sz="1200" dirty="0" err="1"/>
              <a:t>IFN</a:t>
            </a:r>
            <a:r>
              <a:rPr lang="en-US" sz="1200" dirty="0" err="1">
                <a:latin typeface="Symbol" pitchFamily="18" charset="2"/>
              </a:rPr>
              <a:t>g</a:t>
            </a:r>
            <a:r>
              <a:rPr lang="en-US" sz="1200" dirty="0"/>
              <a:t> producing </a:t>
            </a:r>
            <a:r>
              <a:rPr lang="en-US" sz="1200" dirty="0" smtClean="0"/>
              <a:t>cells </a:t>
            </a:r>
            <a:r>
              <a:rPr lang="en-US" sz="1200" dirty="0"/>
              <a:t>per 10</a:t>
            </a:r>
            <a:r>
              <a:rPr lang="en-US" sz="1200" baseline="30000" dirty="0"/>
              <a:t>6</a:t>
            </a:r>
            <a:r>
              <a:rPr lang="en-US" sz="1200" dirty="0"/>
              <a:t> PBMC in response to HER2-ECD, HER2–ICD, and CMV peptide mix are </a:t>
            </a:r>
            <a:r>
              <a:rPr lang="en-US" sz="1200" dirty="0" smtClean="0"/>
              <a:t>presented </a:t>
            </a:r>
            <a:r>
              <a:rPr lang="en-US" sz="1200" dirty="0"/>
              <a:t>for each patient at week 0 (pre-vaccination) and week 10 or 12 (post-vaccination).  </a:t>
            </a:r>
            <a:r>
              <a:rPr lang="en-US" sz="1200" dirty="0" err="1" smtClean="0"/>
              <a:t>Mitogen</a:t>
            </a:r>
            <a:r>
              <a:rPr lang="en-US" sz="1200" dirty="0" smtClean="0"/>
              <a:t> positive controls were positive for all assay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87451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4</Words>
  <Application>Microsoft Office PowerPoint</Application>
  <PresentationFormat>On-screen Show (4:3)</PresentationFormat>
  <Paragraphs>8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u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Richberg</dc:creator>
  <cp:lastModifiedBy>Michael Richberg</cp:lastModifiedBy>
  <cp:revision>2</cp:revision>
  <dcterms:created xsi:type="dcterms:W3CDTF">2011-08-26T18:26:24Z</dcterms:created>
  <dcterms:modified xsi:type="dcterms:W3CDTF">2011-11-08T16:08:16Z</dcterms:modified>
</cp:coreProperties>
</file>